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54" d="100"/>
          <a:sy n="154" d="100"/>
        </p:scale>
        <p:origin x="534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4027025-2E31-4A37-BF19-78F892E8D6B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6AAB20DB-2A4D-49DF-A0AE-FD03A17DE60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47FFC6D-AE75-44CD-9D94-61186A71C3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671649-4D07-410B-A8E1-BE030FCEB946}" type="datetimeFigureOut">
              <a:rPr lang="zh-CN" altLang="en-US" smtClean="0"/>
              <a:t>2024-11-0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C789C4B-A287-4DE8-B1C6-EC3628DF80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D36F29E-8969-400F-96A7-7101EC279E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90845-9044-48A3-B310-8C0A58AB45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2623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323FFBC-A56F-49A3-A195-39BC6C257A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396E77E-5E80-42B8-88BD-2F6DFB83A4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7F8DA5C-7358-405D-83E5-FD637E31A5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671649-4D07-410B-A8E1-BE030FCEB946}" type="datetimeFigureOut">
              <a:rPr lang="zh-CN" altLang="en-US" smtClean="0"/>
              <a:t>2024-11-0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FCDF841-5816-4858-AF60-30FBE4CEB9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717F54D-A940-48CE-9C2D-BDD26CA37D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90845-9044-48A3-B310-8C0A58AB45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53070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F84717B-E78B-4A47-985D-E19962AD59A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3BE5507-7CE5-42B5-8423-534683C847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C2D60F6-79E2-43BC-8CAC-D2711C549E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671649-4D07-410B-A8E1-BE030FCEB946}" type="datetimeFigureOut">
              <a:rPr lang="zh-CN" altLang="en-US" smtClean="0"/>
              <a:t>2024-11-0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7ECCCCE-3804-4F69-92C8-548D5E29B4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BCDF3CD-CE88-4B77-809E-E975D425DD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90845-9044-48A3-B310-8C0A58AB45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34350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C626B38-E402-4EBF-B03F-120DCC5487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75C4334-02C5-4104-BEBC-790F47B1A77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7D8A517-BFBF-4647-9A13-CAC440D0B1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671649-4D07-410B-A8E1-BE030FCEB946}" type="datetimeFigureOut">
              <a:rPr lang="zh-CN" altLang="en-US" smtClean="0"/>
              <a:t>2024-11-0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B3F3679-2685-4610-87D8-695302AB53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36D956C-4B3D-40E7-83B4-AC43156C91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90845-9044-48A3-B310-8C0A58AB45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48520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F5582BC-7891-429E-9EBC-F46C94E224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3F49A23-C50E-42CE-B6E3-580E1A6F07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E8A7EF2-F288-44D6-A106-C5F909EA07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671649-4D07-410B-A8E1-BE030FCEB946}" type="datetimeFigureOut">
              <a:rPr lang="zh-CN" altLang="en-US" smtClean="0"/>
              <a:t>2024-11-0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89155DF-AC55-4339-92A8-4A8248C8DB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FBDFD2D-1EFF-40EF-A071-6CF0F1DDD0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90845-9044-48A3-B310-8C0A58AB45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25479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E17A222-F52B-44E8-9613-8B6494FE45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A79BA07-F74A-492E-A088-28B36EE0CD9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01D5022-1A08-4235-92BE-BE31AEA295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60B687A-69CB-4C79-989F-BF7E0B9766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671649-4D07-410B-A8E1-BE030FCEB946}" type="datetimeFigureOut">
              <a:rPr lang="zh-CN" altLang="en-US" smtClean="0"/>
              <a:t>2024-11-0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02AC7B5-7F52-4447-A8CE-A083342A04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B972B2B-913E-4277-9768-207515931C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90845-9044-48A3-B310-8C0A58AB45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63287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78B7DD0-ACBB-4F89-94E6-D83919CCCF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406346E-26F2-42E2-80EC-C6BB31878E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2302A8E-99FB-4915-B7CF-762E32530EE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B2DAE56-C081-4000-862D-EA802EA8CC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8295B62-B11D-4737-A2D3-D31B2B6C484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F1E2A21-BFAB-419C-A669-62AE09302D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671649-4D07-410B-A8E1-BE030FCEB946}" type="datetimeFigureOut">
              <a:rPr lang="zh-CN" altLang="en-US" smtClean="0"/>
              <a:t>2024-11-0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F2382D67-248F-42EC-BBFF-94FD9BC9FA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571F7D8B-D869-41CA-83F1-16C1A58118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90845-9044-48A3-B310-8C0A58AB45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03934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1FABD13-33A1-4B32-9296-10A243C15B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54C63B2-2F92-4BE8-86C4-67BD450F9F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671649-4D07-410B-A8E1-BE030FCEB946}" type="datetimeFigureOut">
              <a:rPr lang="zh-CN" altLang="en-US" smtClean="0"/>
              <a:t>2024-11-0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2175EDA-D33E-437E-86E8-8EF50123E3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F270559-C722-4DDA-A373-8785577A48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90845-9044-48A3-B310-8C0A58AB45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88004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1D463C3-C94F-489A-B3E8-19A5C81E92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671649-4D07-410B-A8E1-BE030FCEB946}" type="datetimeFigureOut">
              <a:rPr lang="zh-CN" altLang="en-US" smtClean="0"/>
              <a:t>2024-11-0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854EB701-BFDA-4718-BE87-99DF2E9EDF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3A5003DF-9E96-4B7F-A08A-9A9B0ED49B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90845-9044-48A3-B310-8C0A58AB45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71698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C7518F3-14D1-4BBE-B866-85E51EEBF2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C4901EB-1A05-4417-8116-876966D7E2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20CAE09-68BC-4E90-B2CD-ED971B9EF6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29C8BA7-E0DB-47C1-9554-A35820DC4B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671649-4D07-410B-A8E1-BE030FCEB946}" type="datetimeFigureOut">
              <a:rPr lang="zh-CN" altLang="en-US" smtClean="0"/>
              <a:t>2024-11-0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BA650C9-BD2E-4F5E-99F8-3D3060653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7CAA44B-A8E3-4FAF-9AB6-36BC332FC7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90845-9044-48A3-B310-8C0A58AB45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9178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F4EED02-2B66-4559-9B42-338041BAF9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A927978-C1E8-48DC-8EF7-6B91AD455D7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7976716-7832-4C55-916A-DDB7100F1A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47AF660-5528-4B1C-B044-9FF973E7B8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671649-4D07-410B-A8E1-BE030FCEB946}" type="datetimeFigureOut">
              <a:rPr lang="zh-CN" altLang="en-US" smtClean="0"/>
              <a:t>2024-11-0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E480BF1-4398-444C-A93C-6BB96FC728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C782050-5992-4357-8D9C-DB09FB22B7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90845-9044-48A3-B310-8C0A58AB45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32301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09C9607-8382-4F32-9238-7937BFBD68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0E36B78-696A-42A9-9507-63C1EDF831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119C11A-5CA3-4972-A4D5-AC7AC834381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671649-4D07-410B-A8E1-BE030FCEB946}" type="datetimeFigureOut">
              <a:rPr lang="zh-CN" altLang="en-US" smtClean="0"/>
              <a:t>2024-11-0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2167C52-0C76-4C74-9772-5E4ECF0AC98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C6CDBC3-745E-4654-A966-E349FE9F42A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E90845-9044-48A3-B310-8C0A58AB45A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79137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8.tif"/><Relationship Id="rId4" Type="http://schemas.openxmlformats.org/officeDocument/2006/relationships/image" Target="../media/image7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"/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2.tif"/><Relationship Id="rId4" Type="http://schemas.openxmlformats.org/officeDocument/2006/relationships/image" Target="../media/image11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FABD2F89-C10F-4DC4-BC4A-814E67378245}"/>
              </a:ext>
            </a:extLst>
          </p:cNvPr>
          <p:cNvSpPr txBox="1"/>
          <p:nvPr/>
        </p:nvSpPr>
        <p:spPr>
          <a:xfrm>
            <a:off x="242595" y="136849"/>
            <a:ext cx="9877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3</a:t>
            </a:r>
            <a:endParaRPr lang="zh-CN" altLang="en-US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044A0D26-9AF1-4AD2-B15F-D0A97DFC4E6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0213" y="3680926"/>
            <a:ext cx="2212848" cy="304800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1564FC40-518F-43F0-9AE8-18A234089B6B}"/>
              </a:ext>
            </a:extLst>
          </p:cNvPr>
          <p:cNvSpPr txBox="1"/>
          <p:nvPr/>
        </p:nvSpPr>
        <p:spPr>
          <a:xfrm>
            <a:off x="3296817" y="3680926"/>
            <a:ext cx="8996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-actin</a:t>
            </a:r>
            <a:endParaRPr lang="zh-CN" altLang="en-US" dirty="0"/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7C8960BD-B1C9-4B6C-8F9A-5E92DCE38BE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0213" y="3166188"/>
            <a:ext cx="2212848" cy="37795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DB4B597C-666B-49C2-A69F-0D64DC811E25}"/>
              </a:ext>
            </a:extLst>
          </p:cNvPr>
          <p:cNvSpPr txBox="1"/>
          <p:nvPr/>
        </p:nvSpPr>
        <p:spPr>
          <a:xfrm>
            <a:off x="3400210" y="3177074"/>
            <a:ext cx="6928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</a:t>
            </a:r>
            <a:r>
              <a:rPr lang="en-US" altLang="zh-CN" dirty="0" err="1"/>
              <a:t>gp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4455257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FABD2F89-C10F-4DC4-BC4A-814E67378245}"/>
              </a:ext>
            </a:extLst>
          </p:cNvPr>
          <p:cNvSpPr txBox="1"/>
          <p:nvPr/>
        </p:nvSpPr>
        <p:spPr>
          <a:xfrm>
            <a:off x="242595" y="136849"/>
            <a:ext cx="9877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4</a:t>
            </a:r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1564FC40-518F-43F0-9AE8-18A234089B6B}"/>
              </a:ext>
            </a:extLst>
          </p:cNvPr>
          <p:cNvSpPr txBox="1"/>
          <p:nvPr/>
        </p:nvSpPr>
        <p:spPr>
          <a:xfrm>
            <a:off x="3296817" y="3680926"/>
            <a:ext cx="8996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-actin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DB4B597C-666B-49C2-A69F-0D64DC811E25}"/>
              </a:ext>
            </a:extLst>
          </p:cNvPr>
          <p:cNvSpPr txBox="1"/>
          <p:nvPr/>
        </p:nvSpPr>
        <p:spPr>
          <a:xfrm>
            <a:off x="3400210" y="3177074"/>
            <a:ext cx="6928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</a:t>
            </a:r>
            <a:r>
              <a:rPr lang="en-US" altLang="zh-CN" dirty="0" err="1"/>
              <a:t>gp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013CCF4B-621D-4160-85D5-CB14DF976FD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54759" y="3745458"/>
            <a:ext cx="2438400" cy="271537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B4CCD4C3-9E18-476B-9BF6-D8198A1B043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54759" y="3241606"/>
            <a:ext cx="2438400" cy="304800"/>
          </a:xfrm>
          <a:prstGeom prst="rect">
            <a:avLst/>
          </a:prstGeom>
          <a:ln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30092448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FABD2F89-C10F-4DC4-BC4A-814E67378245}"/>
              </a:ext>
            </a:extLst>
          </p:cNvPr>
          <p:cNvSpPr txBox="1"/>
          <p:nvPr/>
        </p:nvSpPr>
        <p:spPr>
          <a:xfrm>
            <a:off x="242595" y="136849"/>
            <a:ext cx="9877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5</a:t>
            </a:r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1564FC40-518F-43F0-9AE8-18A234089B6B}"/>
              </a:ext>
            </a:extLst>
          </p:cNvPr>
          <p:cNvSpPr txBox="1"/>
          <p:nvPr/>
        </p:nvSpPr>
        <p:spPr>
          <a:xfrm>
            <a:off x="1138334" y="1782930"/>
            <a:ext cx="8996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-actin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DB4B597C-666B-49C2-A69F-0D64DC811E25}"/>
              </a:ext>
            </a:extLst>
          </p:cNvPr>
          <p:cNvSpPr txBox="1"/>
          <p:nvPr/>
        </p:nvSpPr>
        <p:spPr>
          <a:xfrm>
            <a:off x="1241727" y="1279078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Nrf</a:t>
            </a:r>
            <a:r>
              <a:rPr lang="en-US" altLang="zh-CN" dirty="0"/>
              <a:t>-2</a:t>
            </a:r>
            <a:endParaRPr lang="zh-CN" altLang="en-US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A94A9A9C-60A2-40E9-9001-44059E0CF4F1}"/>
              </a:ext>
            </a:extLst>
          </p:cNvPr>
          <p:cNvSpPr txBox="1"/>
          <p:nvPr/>
        </p:nvSpPr>
        <p:spPr>
          <a:xfrm>
            <a:off x="472486" y="713224"/>
            <a:ext cx="9140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anel B</a:t>
            </a:r>
            <a:endParaRPr lang="zh-CN" altLang="en-US" dirty="0"/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6B6CA8EA-712F-4D73-8AC5-A4EB000A7C8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7939" y="1830356"/>
            <a:ext cx="4888992" cy="46939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92455EFC-796C-4BE9-9000-238DF930D34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7940" y="1258493"/>
            <a:ext cx="4888992" cy="500724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9F1AF285-AAD9-471B-92C1-8F8BBB19C9B2}"/>
              </a:ext>
            </a:extLst>
          </p:cNvPr>
          <p:cNvSpPr txBox="1"/>
          <p:nvPr/>
        </p:nvSpPr>
        <p:spPr>
          <a:xfrm>
            <a:off x="1138334" y="3776570"/>
            <a:ext cx="8996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-actin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CA39D177-C384-4677-8655-9F357067D1A4}"/>
              </a:ext>
            </a:extLst>
          </p:cNvPr>
          <p:cNvSpPr txBox="1"/>
          <p:nvPr/>
        </p:nvSpPr>
        <p:spPr>
          <a:xfrm>
            <a:off x="1211671" y="3285942"/>
            <a:ext cx="6928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</a:t>
            </a:r>
            <a:r>
              <a:rPr lang="en-US" altLang="zh-CN" dirty="0" err="1"/>
              <a:t>gp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22E3B06-29C0-4DE4-99D0-99634ACC3B72}"/>
              </a:ext>
            </a:extLst>
          </p:cNvPr>
          <p:cNvSpPr txBox="1"/>
          <p:nvPr/>
        </p:nvSpPr>
        <p:spPr>
          <a:xfrm>
            <a:off x="472486" y="2706864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anel C</a:t>
            </a:r>
            <a:endParaRPr lang="zh-CN" altLang="en-US" dirty="0"/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8AA92AAC-ECAF-46C4-BD42-FF8E9900BF5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6457" y="4048322"/>
            <a:ext cx="4114800" cy="304800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5E5639BC-A882-42E7-8042-FF20BD70554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66" t="39094" r="20666" b="40516"/>
          <a:stretch/>
        </p:blipFill>
        <p:spPr>
          <a:xfrm>
            <a:off x="1941811" y="3146744"/>
            <a:ext cx="5351906" cy="74723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23" name="矩形 22">
            <a:extLst>
              <a:ext uri="{FF2B5EF4-FFF2-40B4-BE49-F238E27FC236}">
                <a16:creationId xmlns:a16="http://schemas.microsoft.com/office/drawing/2014/main" id="{C5D039F0-5A8B-4FF0-B5A3-95AC05CE8DB6}"/>
              </a:ext>
            </a:extLst>
          </p:cNvPr>
          <p:cNvSpPr/>
          <p:nvPr/>
        </p:nvSpPr>
        <p:spPr>
          <a:xfrm>
            <a:off x="2600131" y="3234612"/>
            <a:ext cx="3937518" cy="317241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52577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FABD2F89-C10F-4DC4-BC4A-814E67378245}"/>
              </a:ext>
            </a:extLst>
          </p:cNvPr>
          <p:cNvSpPr txBox="1"/>
          <p:nvPr/>
        </p:nvSpPr>
        <p:spPr>
          <a:xfrm>
            <a:off x="242595" y="136849"/>
            <a:ext cx="9877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5</a:t>
            </a:r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1564FC40-518F-43F0-9AE8-18A234089B6B}"/>
              </a:ext>
            </a:extLst>
          </p:cNvPr>
          <p:cNvSpPr txBox="1"/>
          <p:nvPr/>
        </p:nvSpPr>
        <p:spPr>
          <a:xfrm>
            <a:off x="1138334" y="1782930"/>
            <a:ext cx="8996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-actin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DB4B597C-666B-49C2-A69F-0D64DC811E25}"/>
              </a:ext>
            </a:extLst>
          </p:cNvPr>
          <p:cNvSpPr txBox="1"/>
          <p:nvPr/>
        </p:nvSpPr>
        <p:spPr>
          <a:xfrm>
            <a:off x="1241727" y="1279078"/>
            <a:ext cx="9172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Keap</a:t>
            </a:r>
            <a:r>
              <a:rPr lang="en-US" altLang="zh-CN" dirty="0"/>
              <a:t>-1</a:t>
            </a:r>
            <a:endParaRPr lang="zh-CN" altLang="en-US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A94A9A9C-60A2-40E9-9001-44059E0CF4F1}"/>
              </a:ext>
            </a:extLst>
          </p:cNvPr>
          <p:cNvSpPr txBox="1"/>
          <p:nvPr/>
        </p:nvSpPr>
        <p:spPr>
          <a:xfrm>
            <a:off x="472486" y="713224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anel C</a:t>
            </a:r>
            <a:endParaRPr lang="zh-CN" altLang="en-US" dirty="0"/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B841AB01-5C58-42E3-8B73-9EA3FA22167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0810" y="1924508"/>
            <a:ext cx="2450592" cy="310896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C7A9E79B-0629-47C9-8B1A-03D687FE1D8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0810" y="1279078"/>
            <a:ext cx="2450592" cy="457200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100DE8B5-ED0B-4D33-9A7C-08D8FC9350D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4161" y="3321884"/>
            <a:ext cx="2044582" cy="516108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590B8FC6-4720-4E8D-8063-6A17E235248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4161" y="2499670"/>
            <a:ext cx="2042160" cy="646176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24" name="文本框 23">
            <a:extLst>
              <a:ext uri="{FF2B5EF4-FFF2-40B4-BE49-F238E27FC236}">
                <a16:creationId xmlns:a16="http://schemas.microsoft.com/office/drawing/2014/main" id="{27105AB0-6F4C-4A0B-8310-2476A33187F1}"/>
              </a:ext>
            </a:extLst>
          </p:cNvPr>
          <p:cNvSpPr txBox="1"/>
          <p:nvPr/>
        </p:nvSpPr>
        <p:spPr>
          <a:xfrm>
            <a:off x="1230366" y="3423563"/>
            <a:ext cx="8883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His-</a:t>
            </a:r>
            <a:r>
              <a:rPr lang="en-US" altLang="zh-CN" dirty="0" err="1"/>
              <a:t>H3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17FD2CFA-6A3F-4164-8CC6-B0C265231BA3}"/>
              </a:ext>
            </a:extLst>
          </p:cNvPr>
          <p:cNvSpPr txBox="1"/>
          <p:nvPr/>
        </p:nvSpPr>
        <p:spPr>
          <a:xfrm>
            <a:off x="1301840" y="2735045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Nrf</a:t>
            </a:r>
            <a:r>
              <a:rPr lang="en-US" altLang="zh-CN" dirty="0"/>
              <a:t>-2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0914476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26</Words>
  <Application>Microsoft Office PowerPoint</Application>
  <PresentationFormat>宽屏</PresentationFormat>
  <Paragraphs>19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istrator</cp:lastModifiedBy>
  <cp:revision>3</cp:revision>
  <dcterms:created xsi:type="dcterms:W3CDTF">2024-11-05T09:42:40Z</dcterms:created>
  <dcterms:modified xsi:type="dcterms:W3CDTF">2024-11-05T10:01:49Z</dcterms:modified>
</cp:coreProperties>
</file>